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45"/>
    <p:restoredTop sz="94694"/>
  </p:normalViewPr>
  <p:slideViewPr>
    <p:cSldViewPr snapToGrid="0">
      <p:cViewPr varScale="1">
        <p:scale>
          <a:sx n="101" d="100"/>
          <a:sy n="101" d="100"/>
        </p:scale>
        <p:origin x="34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382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039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701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986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82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832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265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657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136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008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884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747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597649A-9CAA-1D43-B2E0-664667399565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FB299A-525A-9844-87EC-94EDEB48D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275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8" name="Picture 1347">
            <a:extLst>
              <a:ext uri="{FF2B5EF4-FFF2-40B4-BE49-F238E27FC236}">
                <a16:creationId xmlns:a16="http://schemas.microsoft.com/office/drawing/2014/main" id="{E583B543-F100-26A7-40A2-38E4F62815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10"/>
          <a:stretch/>
        </p:blipFill>
        <p:spPr>
          <a:xfrm>
            <a:off x="923190" y="2579244"/>
            <a:ext cx="4694321" cy="2881384"/>
          </a:xfrm>
          <a:prstGeom prst="rect">
            <a:avLst/>
          </a:prstGeom>
        </p:spPr>
      </p:pic>
      <p:pic>
        <p:nvPicPr>
          <p:cNvPr id="1349" name="Picture 1348">
            <a:extLst>
              <a:ext uri="{FF2B5EF4-FFF2-40B4-BE49-F238E27FC236}">
                <a16:creationId xmlns:a16="http://schemas.microsoft.com/office/drawing/2014/main" id="{1AB85EB7-DBBD-F5A6-33E4-BA16EEF2675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0"/>
          <a:stretch/>
        </p:blipFill>
        <p:spPr>
          <a:xfrm>
            <a:off x="923192" y="5472095"/>
            <a:ext cx="4561535" cy="2757505"/>
          </a:xfrm>
          <a:prstGeom prst="rect">
            <a:avLst/>
          </a:prstGeom>
        </p:spPr>
      </p:pic>
      <p:pic>
        <p:nvPicPr>
          <p:cNvPr id="1350" name="Picture 1349">
            <a:extLst>
              <a:ext uri="{FF2B5EF4-FFF2-40B4-BE49-F238E27FC236}">
                <a16:creationId xmlns:a16="http://schemas.microsoft.com/office/drawing/2014/main" id="{EFAC4902-A449-C0C9-C0F2-EA8995B96C3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64"/>
          <a:stretch/>
        </p:blipFill>
        <p:spPr>
          <a:xfrm>
            <a:off x="931983" y="218558"/>
            <a:ext cx="4703884" cy="2464683"/>
          </a:xfrm>
          <a:prstGeom prst="rect">
            <a:avLst/>
          </a:prstGeom>
        </p:spPr>
      </p:pic>
      <p:sp>
        <p:nvSpPr>
          <p:cNvPr id="1356" name="TextBox 1355">
            <a:extLst>
              <a:ext uri="{FF2B5EF4-FFF2-40B4-BE49-F238E27FC236}">
                <a16:creationId xmlns:a16="http://schemas.microsoft.com/office/drawing/2014/main" id="{1FAC0489-CBAC-B39C-E76D-B330071F669B}"/>
              </a:ext>
            </a:extLst>
          </p:cNvPr>
          <p:cNvSpPr txBox="1"/>
          <p:nvPr/>
        </p:nvSpPr>
        <p:spPr>
          <a:xfrm>
            <a:off x="841862" y="21980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57" name="TextBox 1356">
            <a:extLst>
              <a:ext uri="{FF2B5EF4-FFF2-40B4-BE49-F238E27FC236}">
                <a16:creationId xmlns:a16="http://schemas.microsoft.com/office/drawing/2014/main" id="{E320493E-683C-7ED4-A0DA-944DB0A294BC}"/>
              </a:ext>
            </a:extLst>
          </p:cNvPr>
          <p:cNvSpPr txBox="1"/>
          <p:nvPr/>
        </p:nvSpPr>
        <p:spPr>
          <a:xfrm>
            <a:off x="849878" y="263183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58" name="TextBox 1357">
            <a:extLst>
              <a:ext uri="{FF2B5EF4-FFF2-40B4-BE49-F238E27FC236}">
                <a16:creationId xmlns:a16="http://schemas.microsoft.com/office/drawing/2014/main" id="{97A9D75A-A365-35A6-4AB3-C4689CFB6C62}"/>
              </a:ext>
            </a:extLst>
          </p:cNvPr>
          <p:cNvSpPr txBox="1"/>
          <p:nvPr/>
        </p:nvSpPr>
        <p:spPr>
          <a:xfrm>
            <a:off x="841862" y="541899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14713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>
            <a:extLst>
              <a:ext uri="{FF2B5EF4-FFF2-40B4-BE49-F238E27FC236}">
                <a16:creationId xmlns:a16="http://schemas.microsoft.com/office/drawing/2014/main" id="{CA20D5A2-CF2F-48EB-F848-5756A9F4F3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7355" y="819152"/>
            <a:ext cx="5520690" cy="1590676"/>
          </a:xfrm>
        </p:spPr>
        <p:txBody>
          <a:bodyPr>
            <a:no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12: MS/MS Spectra for Modified Peptides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Dependent Acquisition (DDA) MS/MS spectra of ions corresponding to MALDI-IMS features from Figure 6 matching peptides with 1 or more modified hydroxyproline residues identified as belong to COL1A1. Fragment ions from each precursor confirm the existence of modified hydroxyproline residues. A singly modified peptide IAGQRGVVGLP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ox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) at 1082.63 m/z was detected with multiple y-ions containing the hydroxyproline residue from this precursor. MS/MS spectra for fragments of the peptide G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56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P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ox)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QGVP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ox)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DLGAP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ox)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 m/z 1426.68 containing 3 HYP residues (B) and the corresponding peptide GKP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ox)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QGVPGDLGAP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ox)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 m/z 1426.68 containing 2 HYPs (C) differ in b-and y- ion m/z by 16 m/z (15.994) at b9/y7 corresponding to the difference of 1 HYP modification. Note that in (C) fragments b6 and y13++ share the same m/z in MS/MS scan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4175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199</Words>
  <Application>Microsoft Macintosh PowerPoint</Application>
  <PresentationFormat>Custom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Supplemental Figure 12: MS/MS Spectra for Modified Peptides. Data Dependent Acquisition (DDA) MS/MS spectra of ions corresponding to MALDI-IMS features from Figure 6 matching peptides with 1 or more modified hydroxyproline residues identified as belong to COL1A1. Fragment ions from each precursor confirm the existence of modified hydroxyproline residues. A singly modified peptide IAGQRGVVGLP(ox), (A) at 1082.63 m/z was detected with multiple y-ions containing the hydroxyproline residue from this precursor. MS/MS spectra for fragments of the peptide G656KP(ox)GEQGVP(ox)GDLGAP(ox) at m/z 1426.68 containing 3 HYP residues (B) and the corresponding peptide GKP(ox)GEQGVPGDLGAP(ox) at m/z 1426.68 containing 2 HYPs (C) differ in b-and y- ion m/z by 16 m/z (15.994) at b9/y7 corresponding to the difference of 1 HYP modification. Note that in (C) fragments b6 and y13++ share the same m/z in MS/MS scans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 Schurman</dc:creator>
  <cp:lastModifiedBy>Charlie Schurman</cp:lastModifiedBy>
  <cp:revision>7</cp:revision>
  <dcterms:created xsi:type="dcterms:W3CDTF">2024-04-26T20:58:22Z</dcterms:created>
  <dcterms:modified xsi:type="dcterms:W3CDTF">2025-09-12T22:26:26Z</dcterms:modified>
</cp:coreProperties>
</file>